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0AD520-7ABE-490A-8B6C-2C3A1DD0735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080" y="644616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453CB7-7A8F-4940-938F-9917EFA9BF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49380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0DED28-DDE2-44CD-96A6-262F980847A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040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4672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08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040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4672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CF2D2A-46BE-4E9A-AA54-D65AA3C895C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5C3843-A4C2-4E11-AA32-C94EE20160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059C6C-D1D7-47C6-A921-81AE64D171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DB0F85-764D-47D0-9F69-7AD1EAA1E4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DEA8C4-C61B-4EAF-8D93-CD73240CC3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080" y="812520"/>
            <a:ext cx="5815080" cy="699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2CD348-6F56-44D6-8ECA-4ADDC63C93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8BE87C-936E-469B-AC9A-EA462CF0BA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49380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CBE500-01F5-45D4-A6F5-4FFBD84E01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96DDB7-C4C8-45C2-A7D9-36C970AD47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1444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2880" y="8331120"/>
            <a:ext cx="215748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31120"/>
            <a:ext cx="141444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nl-NL" sz="2400" spc="-1" strike="noStrike">
                <a:solidFill>
                  <a:srgbClr val="000000"/>
                </a:solidFill>
                <a:latin typeface="Times New Roman"/>
                <a:ea typeface="Lucida Sans Unicode"/>
              </a:defRPr>
            </a:lvl1pPr>
          </a:lstStyle>
          <a:p>
            <a:pPr indent="0"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2652ED87-AE27-44DA-9058-7915A1C960D3}" type="slidenum">
              <a:rPr b="0" lang="nl-NL" sz="2400" spc="-1" strike="noStrike">
                <a:solidFill>
                  <a:srgbClr val="000000"/>
                </a:solidFill>
                <a:latin typeface="Times New Roman"/>
                <a:ea typeface="Lucida Sans Unicode"/>
              </a:rPr>
              <a:t>&lt;number&gt;</a:t>
            </a:fld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1.png"/><Relationship Id="rId4" Type="http://schemas.openxmlformats.org/officeDocument/2006/relationships/image" Target="../media/image3.wmf"/><Relationship Id="rId5" Type="http://schemas.openxmlformats.org/officeDocument/2006/relationships/image" Target="../media/image4.wmf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rcRect l="1395" t="0" r="23323" b="0"/>
          <a:stretch/>
        </p:blipFill>
        <p:spPr>
          <a:xfrm>
            <a:off x="620640" y="1835280"/>
            <a:ext cx="863640" cy="235260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5"/>
          <p:cNvSpPr/>
          <p:nvPr/>
        </p:nvSpPr>
        <p:spPr>
          <a:xfrm rot="16200000">
            <a:off x="423720" y="1335600"/>
            <a:ext cx="582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Times New Roman"/>
              </a:rPr>
              <a:t>Old (130-13)</a:t>
            </a:r>
            <a:endParaRPr b="0" lang="en-US" sz="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3" name="Rectangle 6"/>
          <p:cNvSpPr/>
          <p:nvPr/>
        </p:nvSpPr>
        <p:spPr>
          <a:xfrm rot="16200000">
            <a:off x="539640" y="1458720"/>
            <a:ext cx="808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Times New Roman"/>
              </a:rPr>
              <a:t>Csb</a:t>
            </a:r>
            <a:r>
              <a:rPr b="1" i="1" lang="en-US" sz="8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m/m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Times New Roman"/>
              </a:rPr>
              <a:t>/Xpa</a:t>
            </a:r>
            <a:r>
              <a:rPr b="1" i="1" lang="en-US" sz="8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-/-</a:t>
            </a:r>
            <a:endParaRPr b="0" lang="en-US" sz="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4" name="Rectangle 7"/>
          <p:cNvSpPr/>
          <p:nvPr/>
        </p:nvSpPr>
        <p:spPr>
          <a:xfrm rot="16200000">
            <a:off x="731520" y="1447560"/>
            <a:ext cx="808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Times New Roman"/>
              </a:rPr>
              <a:t>Ercc1</a:t>
            </a:r>
            <a:r>
              <a:rPr b="1" i="1" lang="en-US" sz="8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-/Δ-7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endParaRPr b="0" lang="en-US" sz="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5" name="Rectangle 8"/>
          <p:cNvSpPr/>
          <p:nvPr/>
        </p:nvSpPr>
        <p:spPr>
          <a:xfrm rot="16200000">
            <a:off x="1161360" y="1232640"/>
            <a:ext cx="380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Times New Roman"/>
              </a:rPr>
              <a:t>HypoTh</a:t>
            </a:r>
            <a:endParaRPr b="0" lang="en-US" sz="800" spc="-1" strike="noStrike">
              <a:solidFill>
                <a:srgbClr val="ffffff"/>
              </a:solidFill>
              <a:latin typeface="Times New Roman"/>
            </a:endParaRPr>
          </a:p>
        </p:txBody>
      </p:sp>
      <p:pic>
        <p:nvPicPr>
          <p:cNvPr id="46" name="Image 1" descr=""/>
          <p:cNvPicPr/>
          <p:nvPr/>
        </p:nvPicPr>
        <p:blipFill>
          <a:blip r:embed="rId2"/>
          <a:srcRect l="0" t="0" r="0" b="97592"/>
          <a:stretch/>
        </p:blipFill>
        <p:spPr>
          <a:xfrm>
            <a:off x="189000" y="898560"/>
            <a:ext cx="1650960" cy="17604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11" descr=""/>
          <p:cNvPicPr/>
          <p:nvPr/>
        </p:nvPicPr>
        <p:blipFill>
          <a:blip r:embed="rId3"/>
          <a:srcRect l="74906" t="0" r="0" b="0"/>
          <a:stretch/>
        </p:blipFill>
        <p:spPr>
          <a:xfrm>
            <a:off x="1484280" y="1835280"/>
            <a:ext cx="647640" cy="2352600"/>
          </a:xfrm>
          <a:prstGeom prst="rect">
            <a:avLst/>
          </a:prstGeom>
          <a:ln w="0">
            <a:noFill/>
          </a:ln>
        </p:spPr>
      </p:pic>
      <p:sp>
        <p:nvSpPr>
          <p:cNvPr id="48" name="Text Box 12"/>
          <p:cNvSpPr/>
          <p:nvPr/>
        </p:nvSpPr>
        <p:spPr>
          <a:xfrm>
            <a:off x="0" y="7885080"/>
            <a:ext cx="685800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S3 Fig </a:t>
            </a:r>
            <a:r>
              <a:rPr b="0" lang="nl-NL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(A)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Expression of the selected 15 T3-responsive target genes (see Fig. 1C,D) in the datasets comprising naturally old (130 vs 13-week-old), premature aging (15-day-old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Csb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m/m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/Xpa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-/-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and 16-week-old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Ercc1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-/Δ-7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) mice and hypothyroid mice compared with their corresponding controls. Gene expression levels: red, up-regulated genes compared to the geometric mean; blue, down-regulated genes compared to the geometric mean; grey: no data available. The color intensity correlates with the degree of change. (B) Expression profiling of a set of known T3-responsive genes in 13-wk-old and 130-wk-old mice.</a:t>
            </a:r>
            <a:endParaRPr b="0" lang="en-US" sz="1100" spc="-1" strike="noStrike">
              <a:solidFill>
                <a:srgbClr val="ffffff"/>
              </a:solidFill>
              <a:latin typeface="Times New Roman"/>
            </a:endParaRPr>
          </a:p>
        </p:txBody>
      </p:sp>
      <p:pic>
        <p:nvPicPr>
          <p:cNvPr id="49" name="Picture 10" descr=""/>
          <p:cNvPicPr/>
          <p:nvPr/>
        </p:nvPicPr>
        <p:blipFill>
          <a:blip r:embed="rId4"/>
          <a:stretch/>
        </p:blipFill>
        <p:spPr>
          <a:xfrm>
            <a:off x="260280" y="4859280"/>
            <a:ext cx="3960720" cy="1698840"/>
          </a:xfrm>
          <a:prstGeom prst="rect">
            <a:avLst/>
          </a:prstGeom>
          <a:ln w="0">
            <a:noFill/>
          </a:ln>
        </p:spPr>
      </p:pic>
      <p:sp>
        <p:nvSpPr>
          <p:cNvPr id="50" name="Text Box 19"/>
          <p:cNvSpPr/>
          <p:nvPr/>
        </p:nvSpPr>
        <p:spPr>
          <a:xfrm>
            <a:off x="1484280" y="6588000"/>
            <a:ext cx="1890720" cy="37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000" spc="-1" strike="noStrike">
                <a:solidFill>
                  <a:srgbClr val="000000"/>
                </a:solidFill>
                <a:latin typeface="Arial"/>
                <a:ea typeface="Lucida Sans Unicode"/>
              </a:rPr>
              <a:t>Genes suppressed in hypothyroidism</a:t>
            </a:r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1" name="Text Box 20"/>
          <p:cNvSpPr/>
          <p:nvPr/>
        </p:nvSpPr>
        <p:spPr>
          <a:xfrm>
            <a:off x="4626000" y="6588000"/>
            <a:ext cx="1260360" cy="247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000" spc="-1" strike="noStrike">
                <a:solidFill>
                  <a:srgbClr val="000000"/>
                </a:solidFill>
                <a:latin typeface="Arial"/>
                <a:ea typeface="Lucida Sans Unicode"/>
              </a:rPr>
              <a:t>Genes induced in hypothyroidism</a:t>
            </a:r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  <p:pic>
        <p:nvPicPr>
          <p:cNvPr id="52" name="Picture 1" descr=""/>
          <p:cNvPicPr/>
          <p:nvPr/>
        </p:nvPicPr>
        <p:blipFill>
          <a:blip r:embed="rId5"/>
          <a:stretch/>
        </p:blipFill>
        <p:spPr>
          <a:xfrm>
            <a:off x="4543560" y="4859280"/>
            <a:ext cx="1189080" cy="1677960"/>
          </a:xfrm>
          <a:prstGeom prst="rect">
            <a:avLst/>
          </a:prstGeom>
          <a:ln w="0">
            <a:noFill/>
          </a:ln>
        </p:spPr>
      </p:pic>
      <p:sp>
        <p:nvSpPr>
          <p:cNvPr id="53" name="Text Box 2"/>
          <p:cNvSpPr/>
          <p:nvPr/>
        </p:nvSpPr>
        <p:spPr>
          <a:xfrm>
            <a:off x="0" y="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A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4" name="Text Box 2"/>
          <p:cNvSpPr/>
          <p:nvPr/>
        </p:nvSpPr>
        <p:spPr>
          <a:xfrm>
            <a:off x="31680" y="4356000"/>
            <a:ext cx="381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B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09T09:26:31Z</dcterms:created>
  <dc:creator>USER</dc:creator>
  <dc:description/>
  <dc:language>en-US</dc:language>
  <cp:lastModifiedBy>Edward Visser</cp:lastModifiedBy>
  <dcterms:modified xsi:type="dcterms:W3CDTF">2016-02-11T12:44:58Z</dcterms:modified>
  <cp:revision>111</cp:revision>
  <dc:subject/>
  <dc:title>PowerPoint Presentation</dc:title>
</cp:coreProperties>
</file>